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88" r:id="rId3"/>
    <p:sldId id="29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33" autoAdjust="0"/>
    <p:restoredTop sz="87662" autoAdjust="0"/>
  </p:normalViewPr>
  <p:slideViewPr>
    <p:cSldViewPr>
      <p:cViewPr varScale="1">
        <p:scale>
          <a:sx n="80" d="100"/>
          <a:sy n="80" d="100"/>
        </p:scale>
        <p:origin x="1008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DEEF8B-C243-411B-8716-B0E1C8DC5E05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400AB7-1D6F-4AC7-81F7-0BECF3B432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4540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400AB7-1D6F-4AC7-81F7-0BECF3B4323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9143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400AB7-1D6F-4AC7-81F7-0BECF3B4323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4344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379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637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1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1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75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210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505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3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3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648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509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577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890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3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293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043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3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3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99C06-1DCA-44BA-BB2E-16D86D6EA371}" type="datetimeFigureOut">
              <a:rPr lang="en-US" smtClean="0"/>
              <a:t>3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3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3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CC83B-93A2-4DBC-90DE-E3FF2112B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263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" Type="http://schemas.openxmlformats.org/officeDocument/2006/relationships/image" Target="../media/image1.jpeg"/><Relationship Id="rId21" Type="http://schemas.openxmlformats.org/officeDocument/2006/relationships/image" Target="../media/image19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8.tiff"/><Relationship Id="rId18" Type="http://schemas.openxmlformats.org/officeDocument/2006/relationships/image" Target="../media/image43.tiff"/><Relationship Id="rId26" Type="http://schemas.openxmlformats.org/officeDocument/2006/relationships/image" Target="../media/image50.tiff"/><Relationship Id="rId39" Type="http://schemas.openxmlformats.org/officeDocument/2006/relationships/image" Target="../media/image60.png"/><Relationship Id="rId21" Type="http://schemas.openxmlformats.org/officeDocument/2006/relationships/image" Target="../media/image46.tiff"/><Relationship Id="rId34" Type="http://schemas.microsoft.com/office/2007/relationships/hdphoto" Target="../media/hdphoto3.wdp"/><Relationship Id="rId42" Type="http://schemas.openxmlformats.org/officeDocument/2006/relationships/image" Target="../media/image62.tiff"/><Relationship Id="rId7" Type="http://schemas.openxmlformats.org/officeDocument/2006/relationships/image" Target="../media/image32.tif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41.tiff"/><Relationship Id="rId20" Type="http://schemas.openxmlformats.org/officeDocument/2006/relationships/image" Target="../media/image45.tiff"/><Relationship Id="rId29" Type="http://schemas.openxmlformats.org/officeDocument/2006/relationships/image" Target="../media/image52.tiff"/><Relationship Id="rId41" Type="http://schemas.openxmlformats.org/officeDocument/2006/relationships/image" Target="../media/image6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tiff"/><Relationship Id="rId11" Type="http://schemas.openxmlformats.org/officeDocument/2006/relationships/image" Target="../media/image36.tiff"/><Relationship Id="rId24" Type="http://schemas.microsoft.com/office/2007/relationships/hdphoto" Target="../media/hdphoto1.wdp"/><Relationship Id="rId32" Type="http://schemas.openxmlformats.org/officeDocument/2006/relationships/image" Target="../media/image55.tiff"/><Relationship Id="rId37" Type="http://schemas.openxmlformats.org/officeDocument/2006/relationships/image" Target="../media/image59.png"/><Relationship Id="rId40" Type="http://schemas.microsoft.com/office/2007/relationships/hdphoto" Target="../media/hdphoto5.wdp"/><Relationship Id="rId5" Type="http://schemas.openxmlformats.org/officeDocument/2006/relationships/image" Target="../media/image30.tiff"/><Relationship Id="rId15" Type="http://schemas.openxmlformats.org/officeDocument/2006/relationships/image" Target="../media/image40.tiff"/><Relationship Id="rId23" Type="http://schemas.openxmlformats.org/officeDocument/2006/relationships/image" Target="../media/image48.png"/><Relationship Id="rId28" Type="http://schemas.microsoft.com/office/2007/relationships/hdphoto" Target="../media/hdphoto2.wdp"/><Relationship Id="rId36" Type="http://schemas.openxmlformats.org/officeDocument/2006/relationships/image" Target="../media/image58.tiff"/><Relationship Id="rId10" Type="http://schemas.openxmlformats.org/officeDocument/2006/relationships/image" Target="../media/image35.tiff"/><Relationship Id="rId19" Type="http://schemas.openxmlformats.org/officeDocument/2006/relationships/image" Target="../media/image44.tiff"/><Relationship Id="rId31" Type="http://schemas.openxmlformats.org/officeDocument/2006/relationships/image" Target="../media/image54.tiff"/><Relationship Id="rId44" Type="http://schemas.microsoft.com/office/2007/relationships/hdphoto" Target="../media/hdphoto6.wdp"/><Relationship Id="rId4" Type="http://schemas.openxmlformats.org/officeDocument/2006/relationships/image" Target="../media/image29.jpeg"/><Relationship Id="rId9" Type="http://schemas.openxmlformats.org/officeDocument/2006/relationships/image" Target="../media/image34.tiff"/><Relationship Id="rId14" Type="http://schemas.openxmlformats.org/officeDocument/2006/relationships/image" Target="../media/image39.tiff"/><Relationship Id="rId22" Type="http://schemas.openxmlformats.org/officeDocument/2006/relationships/image" Target="../media/image47.tiff"/><Relationship Id="rId27" Type="http://schemas.openxmlformats.org/officeDocument/2006/relationships/image" Target="../media/image51.png"/><Relationship Id="rId30" Type="http://schemas.openxmlformats.org/officeDocument/2006/relationships/image" Target="../media/image53.tiff"/><Relationship Id="rId35" Type="http://schemas.openxmlformats.org/officeDocument/2006/relationships/image" Target="../media/image57.tiff"/><Relationship Id="rId43" Type="http://schemas.openxmlformats.org/officeDocument/2006/relationships/image" Target="../media/image63.png"/><Relationship Id="rId8" Type="http://schemas.openxmlformats.org/officeDocument/2006/relationships/image" Target="../media/image33.tiff"/><Relationship Id="rId3" Type="http://schemas.openxmlformats.org/officeDocument/2006/relationships/image" Target="../media/image28.tiff"/><Relationship Id="rId12" Type="http://schemas.openxmlformats.org/officeDocument/2006/relationships/image" Target="../media/image37.tiff"/><Relationship Id="rId17" Type="http://schemas.openxmlformats.org/officeDocument/2006/relationships/image" Target="../media/image42.tiff"/><Relationship Id="rId25" Type="http://schemas.openxmlformats.org/officeDocument/2006/relationships/image" Target="../media/image49.tiff"/><Relationship Id="rId33" Type="http://schemas.openxmlformats.org/officeDocument/2006/relationships/image" Target="../media/image56.png"/><Relationship Id="rId38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Histopathology Manuscript </a:t>
            </a:r>
            <a:br>
              <a:rPr lang="en-US" dirty="0"/>
            </a:br>
            <a:r>
              <a:rPr lang="en-US" dirty="0"/>
              <a:t>Supplemental Figure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2004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1FD75-5BDB-4FCA-BE03-D84C2B4B5F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694EEE3-4FF5-4E53-86FA-B0DCC0D74656}"/>
              </a:ext>
            </a:extLst>
          </p:cNvPr>
          <p:cNvSpPr txBox="1"/>
          <p:nvPr/>
        </p:nvSpPr>
        <p:spPr>
          <a:xfrm rot="16200000">
            <a:off x="-89334" y="5244713"/>
            <a:ext cx="1092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RTKA-N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A991E62-1176-48B7-9DE1-988012331AE4}"/>
              </a:ext>
            </a:extLst>
          </p:cNvPr>
          <p:cNvSpPr txBox="1"/>
          <p:nvPr/>
        </p:nvSpPr>
        <p:spPr>
          <a:xfrm rot="16200000">
            <a:off x="-89334" y="3906457"/>
            <a:ext cx="1092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RTKA-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F681968-3823-4D46-87C6-F9D2EBF26DA2}"/>
              </a:ext>
            </a:extLst>
          </p:cNvPr>
          <p:cNvSpPr txBox="1"/>
          <p:nvPr/>
        </p:nvSpPr>
        <p:spPr>
          <a:xfrm rot="16200000">
            <a:off x="-89334" y="2568201"/>
            <a:ext cx="1092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PTK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2AFB479-3CE5-4BE3-87FA-D5FE2F3368BA}"/>
              </a:ext>
            </a:extLst>
          </p:cNvPr>
          <p:cNvSpPr txBox="1"/>
          <p:nvPr/>
        </p:nvSpPr>
        <p:spPr>
          <a:xfrm>
            <a:off x="1940375" y="1600200"/>
            <a:ext cx="1092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ample 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3125147-1835-4E34-8D06-CB8BDEBA72FF}"/>
              </a:ext>
            </a:extLst>
          </p:cNvPr>
          <p:cNvSpPr txBox="1"/>
          <p:nvPr/>
        </p:nvSpPr>
        <p:spPr>
          <a:xfrm>
            <a:off x="5824697" y="1600817"/>
            <a:ext cx="1092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ample 2</a:t>
            </a:r>
          </a:p>
        </p:txBody>
      </p:sp>
      <p:pic>
        <p:nvPicPr>
          <p:cNvPr id="42" name="Picture 41" descr="A picture containing red, fruit, close&#10;&#10;Description automatically generated">
            <a:extLst>
              <a:ext uri="{FF2B5EF4-FFF2-40B4-BE49-F238E27FC236}">
                <a16:creationId xmlns:a16="http://schemas.microsoft.com/office/drawing/2014/main" id="{07D3646A-DA94-4BCD-8843-F913DFF41E3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58" y="3479796"/>
            <a:ext cx="1215279" cy="10140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 descr="A picture containing snow, red&#10;&#10;Description automatically generated">
            <a:extLst>
              <a:ext uri="{FF2B5EF4-FFF2-40B4-BE49-F238E27FC236}">
                <a16:creationId xmlns:a16="http://schemas.microsoft.com/office/drawing/2014/main" id="{88904D42-7B5D-4BD6-92C4-42FC5C00CFC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2574" y="3470283"/>
            <a:ext cx="1226678" cy="10235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0AE239A8-D237-4BFF-9647-091FEA99BF4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480" y="2139278"/>
            <a:ext cx="1217045" cy="10155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326800A5-F189-4E51-8593-22FE29A1872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3151" y="2137815"/>
            <a:ext cx="1211190" cy="10106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 descr="A picture containing red&#10;&#10;Description automatically generated">
            <a:extLst>
              <a:ext uri="{FF2B5EF4-FFF2-40B4-BE49-F238E27FC236}">
                <a16:creationId xmlns:a16="http://schemas.microsoft.com/office/drawing/2014/main" id="{7C890682-770F-469E-97DD-D1E5A656A06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970" y="4815103"/>
            <a:ext cx="1217046" cy="10155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EB38AB46-C581-47DC-B82C-40CE1A1B3A4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8843" y="4799073"/>
            <a:ext cx="1229650" cy="10260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DB35427F-43B7-476A-A57C-9B4388D5B7BD}"/>
              </a:ext>
            </a:extLst>
          </p:cNvPr>
          <p:cNvSpPr txBox="1"/>
          <p:nvPr/>
        </p:nvSpPr>
        <p:spPr>
          <a:xfrm>
            <a:off x="9730641" y="1610176"/>
            <a:ext cx="1092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ample 3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3E2A4312-D1AA-4568-8D8D-F14BD7DDACD4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7268" y="2132929"/>
            <a:ext cx="1217045" cy="10155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84E12128-0582-4622-A148-1CAD3717A219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0247" y="2139278"/>
            <a:ext cx="1217045" cy="10155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CB8A5FE0-5D73-40E2-BE55-C52AE8571778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6399" y="2137271"/>
            <a:ext cx="1217046" cy="10155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037241DB-D1DF-48DD-8A75-28A159DD5DBF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7288" y="2137271"/>
            <a:ext cx="1217046" cy="10155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9166AA21-56E2-4BD1-B8A6-6AEBB3D6BDD7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5917" y="2129774"/>
            <a:ext cx="1222250" cy="10198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 descr="A picture containing colorful&#10;&#10;Description automatically generated">
            <a:extLst>
              <a:ext uri="{FF2B5EF4-FFF2-40B4-BE49-F238E27FC236}">
                <a16:creationId xmlns:a16="http://schemas.microsoft.com/office/drawing/2014/main" id="{E01B1D3E-BD74-4B96-B242-CEA74EF9E845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3690" y="2129775"/>
            <a:ext cx="1222251" cy="10198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7D6BD087-F22D-428D-888D-A9B06B034AFF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5920" y="2131985"/>
            <a:ext cx="1222249" cy="10198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1F24485F-4C1E-4ED0-8FEE-FAE55144171A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3461" y="4815103"/>
            <a:ext cx="1220014" cy="10179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Picture 56" descr="A picture containing red, close&#10;&#10;Description automatically generated">
            <a:extLst>
              <a:ext uri="{FF2B5EF4-FFF2-40B4-BE49-F238E27FC236}">
                <a16:creationId xmlns:a16="http://schemas.microsoft.com/office/drawing/2014/main" id="{13004B4F-0C57-4FF7-ABF0-063DEB4F716D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5642" y="4824202"/>
            <a:ext cx="1212043" cy="10113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355CD57D-ACAE-48FD-84F2-F07BA1D425AD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67660" y="4824203"/>
            <a:ext cx="1229648" cy="10260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Picture 58" descr="Background pattern&#10;&#10;Description automatically generated">
            <a:extLst>
              <a:ext uri="{FF2B5EF4-FFF2-40B4-BE49-F238E27FC236}">
                <a16:creationId xmlns:a16="http://schemas.microsoft.com/office/drawing/2014/main" id="{DC6D1ABD-DD5B-4D22-8765-BADFEE53B10F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4090" y="4805629"/>
            <a:ext cx="1229650" cy="10260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Picture 59" descr="A picture containing covered, red, fabric&#10;&#10;Description automatically generated">
            <a:extLst>
              <a:ext uri="{FF2B5EF4-FFF2-40B4-BE49-F238E27FC236}">
                <a16:creationId xmlns:a16="http://schemas.microsoft.com/office/drawing/2014/main" id="{6FA9FF90-AF4F-40B2-AD91-43635629439F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7961" y="4793560"/>
            <a:ext cx="1229650" cy="10260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Picture 60" descr="A picture containing fabric&#10;&#10;Description automatically generated">
            <a:extLst>
              <a:ext uri="{FF2B5EF4-FFF2-40B4-BE49-F238E27FC236}">
                <a16:creationId xmlns:a16="http://schemas.microsoft.com/office/drawing/2014/main" id="{DB0BDE9B-E786-4039-A97C-2115789927E2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0064" y="4809090"/>
            <a:ext cx="1222396" cy="10199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Picture 61" descr="A picture containing indoor, fabric&#10;&#10;Description automatically generated">
            <a:extLst>
              <a:ext uri="{FF2B5EF4-FFF2-40B4-BE49-F238E27FC236}">
                <a16:creationId xmlns:a16="http://schemas.microsoft.com/office/drawing/2014/main" id="{CAC7B6A2-5A5E-49CB-B3B5-281D66C49AB8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0124" y="4815103"/>
            <a:ext cx="1217047" cy="10155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Picture 62" descr="A picture containing red, close, fabric&#10;&#10;Description automatically generated">
            <a:extLst>
              <a:ext uri="{FF2B5EF4-FFF2-40B4-BE49-F238E27FC236}">
                <a16:creationId xmlns:a16="http://schemas.microsoft.com/office/drawing/2014/main" id="{8C407143-E8E8-447B-9DE5-6129D3CC5F7B}"/>
              </a:ext>
            </a:extLst>
          </p:cNvPr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3508" y="3477494"/>
            <a:ext cx="1218952" cy="10171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Picture 63" descr="A picture containing red, citrus, fruit, close&#10;&#10;Description automatically generated">
            <a:extLst>
              <a:ext uri="{FF2B5EF4-FFF2-40B4-BE49-F238E27FC236}">
                <a16:creationId xmlns:a16="http://schemas.microsoft.com/office/drawing/2014/main" id="{7BE50843-10BA-495A-854C-84A30A7A47FB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3709" y="3475392"/>
            <a:ext cx="1218952" cy="10171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FD38BA4A-40BA-427A-9658-DB03890EE733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1523" y="3452513"/>
            <a:ext cx="1252217" cy="10448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2D520258-324E-46C3-866F-743E1945206A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8410" y="3463807"/>
            <a:ext cx="1232839" cy="1028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Picture 66" descr="A picture containing red, rug&#10;&#10;Description automatically generated">
            <a:extLst>
              <a:ext uri="{FF2B5EF4-FFF2-40B4-BE49-F238E27FC236}">
                <a16:creationId xmlns:a16="http://schemas.microsoft.com/office/drawing/2014/main" id="{6E86BE0C-0266-4355-89E1-584FA5BAAC0E}"/>
              </a:ext>
            </a:extLst>
          </p:cNvPr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4127" y="3460941"/>
            <a:ext cx="1218676" cy="10168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0CDE0371-E6BC-43AC-961F-0EFC83E8DC69}"/>
              </a:ext>
            </a:extLst>
          </p:cNvPr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1131" y="3449969"/>
            <a:ext cx="1231826" cy="10278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Picture 68" descr="A picture containing red&#10;&#10;Description automatically generated">
            <a:extLst>
              <a:ext uri="{FF2B5EF4-FFF2-40B4-BE49-F238E27FC236}">
                <a16:creationId xmlns:a16="http://schemas.microsoft.com/office/drawing/2014/main" id="{95039895-B6C5-4EEC-8E78-86ECA5C49D73}"/>
              </a:ext>
            </a:extLst>
          </p:cNvPr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9402" y="3449969"/>
            <a:ext cx="1215279" cy="101404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B9607C38-76B5-45B4-8441-25888247BBD1}"/>
              </a:ext>
            </a:extLst>
          </p:cNvPr>
          <p:cNvCxnSpPr/>
          <p:nvPr/>
        </p:nvCxnSpPr>
        <p:spPr>
          <a:xfrm>
            <a:off x="641827" y="1979508"/>
            <a:ext cx="3695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6044A8FE-C6F1-4F5A-A7D7-F69367A80AD9}"/>
              </a:ext>
            </a:extLst>
          </p:cNvPr>
          <p:cNvCxnSpPr/>
          <p:nvPr/>
        </p:nvCxnSpPr>
        <p:spPr>
          <a:xfrm>
            <a:off x="4485887" y="1979508"/>
            <a:ext cx="36952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5E4266C1-4818-413C-9983-B79A0A6C42C0}"/>
              </a:ext>
            </a:extLst>
          </p:cNvPr>
          <p:cNvCxnSpPr>
            <a:cxnSpLocks/>
          </p:cNvCxnSpPr>
          <p:nvPr/>
        </p:nvCxnSpPr>
        <p:spPr>
          <a:xfrm>
            <a:off x="8418262" y="1979508"/>
            <a:ext cx="3716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118AEE1D-ED24-4AF6-9559-04D85668052B}"/>
              </a:ext>
            </a:extLst>
          </p:cNvPr>
          <p:cNvSpPr txBox="1"/>
          <p:nvPr/>
        </p:nvSpPr>
        <p:spPr>
          <a:xfrm>
            <a:off x="11697690" y="3000890"/>
            <a:ext cx="5053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100 µm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E49A3B91-5585-4A9D-9A21-8BF3AD8E14AD}"/>
              </a:ext>
            </a:extLst>
          </p:cNvPr>
          <p:cNvCxnSpPr>
            <a:cxnSpLocks/>
          </p:cNvCxnSpPr>
          <p:nvPr/>
        </p:nvCxnSpPr>
        <p:spPr>
          <a:xfrm>
            <a:off x="11747242" y="3036270"/>
            <a:ext cx="39978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7CC480E2-1C77-48B8-A3B8-92E0FBDDFE1F}"/>
              </a:ext>
            </a:extLst>
          </p:cNvPr>
          <p:cNvSpPr txBox="1"/>
          <p:nvPr/>
        </p:nvSpPr>
        <p:spPr>
          <a:xfrm>
            <a:off x="457200" y="5975876"/>
            <a:ext cx="116771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1. Picrosirius red staining of periarticular knee tissue. </a:t>
            </a:r>
            <a:r>
              <a:rPr lang="en-US" sz="1400" dirty="0"/>
              <a:t>Picrosirius red staining</a:t>
            </a:r>
            <a:r>
              <a:rPr lang="en-US" sz="1400" b="1" dirty="0"/>
              <a:t> </a:t>
            </a:r>
            <a:r>
              <a:rPr lang="en-US" sz="1400" dirty="0"/>
              <a:t>showing three different regions within each of the samples, from the three patient groups (PTKA=primary TKA, RTKA-A=arthrofibrosis, RTKA-NA=non-arthrofibrosis). The scale bar applies to all images in this figure. </a:t>
            </a:r>
          </a:p>
        </p:txBody>
      </p:sp>
    </p:spTree>
    <p:extLst>
      <p:ext uri="{BB962C8B-B14F-4D97-AF65-F5344CB8AC3E}">
        <p14:creationId xmlns:p14="http://schemas.microsoft.com/office/powerpoint/2010/main" val="3068671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30" descr="A picture containing light, dark, night sky&#10;&#10;Description automatically generated">
            <a:extLst>
              <a:ext uri="{FF2B5EF4-FFF2-40B4-BE49-F238E27FC236}">
                <a16:creationId xmlns:a16="http://schemas.microsoft.com/office/drawing/2014/main" id="{9B58F13D-0F02-4BF3-AC14-F82A2D9CEBF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219793" y="199491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9CA5ED7-232F-4E5D-8728-B008033508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2</a:t>
            </a:r>
            <a:endParaRPr lang="en-US" sz="2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B64ED59-93C0-436E-ACDC-A27EAD55E9A3}"/>
              </a:ext>
            </a:extLst>
          </p:cNvPr>
          <p:cNvSpPr txBox="1"/>
          <p:nvPr/>
        </p:nvSpPr>
        <p:spPr>
          <a:xfrm rot="16200000">
            <a:off x="-361831" y="5212386"/>
            <a:ext cx="109299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RTKA-N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609089E-7048-4346-AA71-5E7279E60E55}"/>
              </a:ext>
            </a:extLst>
          </p:cNvPr>
          <p:cNvSpPr txBox="1"/>
          <p:nvPr/>
        </p:nvSpPr>
        <p:spPr>
          <a:xfrm rot="16200000">
            <a:off x="-361831" y="3838082"/>
            <a:ext cx="109299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RTKA-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2160183-CF06-4836-B780-78ADCD3BE93B}"/>
              </a:ext>
            </a:extLst>
          </p:cNvPr>
          <p:cNvSpPr txBox="1"/>
          <p:nvPr/>
        </p:nvSpPr>
        <p:spPr>
          <a:xfrm rot="16200000">
            <a:off x="-361831" y="2283097"/>
            <a:ext cx="109299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PTK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2CC8870-41C0-4B34-8132-DF17A6833FF6}"/>
              </a:ext>
            </a:extLst>
          </p:cNvPr>
          <p:cNvSpPr txBox="1"/>
          <p:nvPr/>
        </p:nvSpPr>
        <p:spPr>
          <a:xfrm>
            <a:off x="1813710" y="1383674"/>
            <a:ext cx="109299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ample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99EB007-B3EB-4E63-8C66-8445062C961B}"/>
              </a:ext>
            </a:extLst>
          </p:cNvPr>
          <p:cNvSpPr txBox="1"/>
          <p:nvPr/>
        </p:nvSpPr>
        <p:spPr>
          <a:xfrm>
            <a:off x="5612700" y="1383674"/>
            <a:ext cx="109299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ample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4A2567C-CB1A-4C67-AAB1-26B83362687F}"/>
              </a:ext>
            </a:extLst>
          </p:cNvPr>
          <p:cNvSpPr txBox="1"/>
          <p:nvPr/>
        </p:nvSpPr>
        <p:spPr>
          <a:xfrm>
            <a:off x="9722449" y="1371600"/>
            <a:ext cx="109299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ample 3</a:t>
            </a:r>
          </a:p>
        </p:txBody>
      </p:sp>
      <p:pic>
        <p:nvPicPr>
          <p:cNvPr id="4" name="Picture 3" descr="A picture containing invertebrate&#10;&#10;Description automatically generated">
            <a:extLst>
              <a:ext uri="{FF2B5EF4-FFF2-40B4-BE49-F238E27FC236}">
                <a16:creationId xmlns:a16="http://schemas.microsoft.com/office/drawing/2014/main" id="{ACED2A7C-79D0-4D41-B571-F14ED456B7A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184093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A picture containing text&#10;&#10;Description automatically generated">
            <a:extLst>
              <a:ext uri="{FF2B5EF4-FFF2-40B4-BE49-F238E27FC236}">
                <a16:creationId xmlns:a16="http://schemas.microsoft.com/office/drawing/2014/main" id="{379EC857-BA7E-4BDD-93E1-A2D5E4D2034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220739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A picture containing outdoor object, night, night sky&#10;&#10;Description automatically generated">
            <a:extLst>
              <a:ext uri="{FF2B5EF4-FFF2-40B4-BE49-F238E27FC236}">
                <a16:creationId xmlns:a16="http://schemas.microsoft.com/office/drawing/2014/main" id="{3449B8F0-52E6-4251-A129-EA6C8D1FA6D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91388" y="4924608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 descr="A picture containing invertebrate, arthropod, dark&#10;&#10;Description automatically generated">
            <a:extLst>
              <a:ext uri="{FF2B5EF4-FFF2-40B4-BE49-F238E27FC236}">
                <a16:creationId xmlns:a16="http://schemas.microsoft.com/office/drawing/2014/main" id="{02C93DA7-7656-46FD-9F72-3BABBD2D19F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255163" y="4924608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 descr="A picture containing outdoor object, star, night, night sky&#10;&#10;Description automatically generated">
            <a:extLst>
              <a:ext uri="{FF2B5EF4-FFF2-40B4-BE49-F238E27FC236}">
                <a16:creationId xmlns:a16="http://schemas.microsoft.com/office/drawing/2014/main" id="{075FAFEC-F45F-479B-AD2F-110760D7921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99169" y="199491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 descr="A picture containing dark, red, light, star&#10;&#10;Description automatically generated">
            <a:extLst>
              <a:ext uri="{FF2B5EF4-FFF2-40B4-BE49-F238E27FC236}">
                <a16:creationId xmlns:a16="http://schemas.microsoft.com/office/drawing/2014/main" id="{FC4572A0-5FD1-4FCA-86B7-B82E7249F91B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255163" y="199491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 descr="A picture containing outdoor object, star, night sky&#10;&#10;Description automatically generated">
            <a:extLst>
              <a:ext uri="{FF2B5EF4-FFF2-40B4-BE49-F238E27FC236}">
                <a16:creationId xmlns:a16="http://schemas.microsoft.com/office/drawing/2014/main" id="{0B655962-D537-4C04-A812-E064B51CB397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184093" y="199197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B6BCF8BE-70CA-42B1-894F-56DBA7A01AB9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89595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Picture 49" descr="A picture containing indoor, keyboard, outdoor object, black&#10;&#10;Description automatically generated">
            <a:extLst>
              <a:ext uri="{FF2B5EF4-FFF2-40B4-BE49-F238E27FC236}">
                <a16:creationId xmlns:a16="http://schemas.microsoft.com/office/drawing/2014/main" id="{1C432AE2-6DF1-411D-9519-0B99966380EA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250263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 descr="A picture containing dark, light, night&#10;&#10;Description automatically generated">
            <a:extLst>
              <a:ext uri="{FF2B5EF4-FFF2-40B4-BE49-F238E27FC236}">
                <a16:creationId xmlns:a16="http://schemas.microsoft.com/office/drawing/2014/main" id="{CC3A01C1-B9CA-49D1-B292-0505BF81AA8E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219327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Picture 57" descr="A picture containing indoor, keyboard, outdoor object&#10;&#10;Description automatically generated">
            <a:extLst>
              <a:ext uri="{FF2B5EF4-FFF2-40B4-BE49-F238E27FC236}">
                <a16:creationId xmlns:a16="http://schemas.microsoft.com/office/drawing/2014/main" id="{814C150B-6F6C-45B0-AFBE-0E22B6404076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158831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Picture 60" descr="A picture containing dark, night sky&#10;&#10;Description automatically generated">
            <a:extLst>
              <a:ext uri="{FF2B5EF4-FFF2-40B4-BE49-F238E27FC236}">
                <a16:creationId xmlns:a16="http://schemas.microsoft.com/office/drawing/2014/main" id="{3BDAFF2B-0820-43C9-AF57-3B3C8BAE1983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1157474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Picture 62" descr="A picture containing dark, hydrozoan&#10;&#10;Description automatically generated">
            <a:extLst>
              <a:ext uri="{FF2B5EF4-FFF2-40B4-BE49-F238E27FC236}">
                <a16:creationId xmlns:a16="http://schemas.microsoft.com/office/drawing/2014/main" id="{A4D2A6D6-27BC-45C8-B3ED-9BE6D71F9648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0188209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Picture 64" descr="A picture containing indoor, outdoor object, dark, night sky&#10;&#10;Description automatically generated">
            <a:extLst>
              <a:ext uri="{FF2B5EF4-FFF2-40B4-BE49-F238E27FC236}">
                <a16:creationId xmlns:a16="http://schemas.microsoft.com/office/drawing/2014/main" id="{A89A4814-EB6A-47F0-8908-AF1E33662EBB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246649" y="4922836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Picture 66" descr="A picture containing dark&#10;&#10;Description automatically generated">
            <a:extLst>
              <a:ext uri="{FF2B5EF4-FFF2-40B4-BE49-F238E27FC236}">
                <a16:creationId xmlns:a16="http://schemas.microsoft.com/office/drawing/2014/main" id="{CCA6FD07-97CB-4F75-A5C4-76B450712C72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9212729" y="4918921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Picture 68" descr="A picture containing indoor, dark&#10;&#10;Description automatically generated">
            <a:extLst>
              <a:ext uri="{FF2B5EF4-FFF2-40B4-BE49-F238E27FC236}">
                <a16:creationId xmlns:a16="http://schemas.microsoft.com/office/drawing/2014/main" id="{ADE21A8F-76E6-4395-ABC7-5B4033474B7C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149185" y="199197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Picture 70" descr="A picture containing dark&#10;&#10;Description automatically generated">
            <a:extLst>
              <a:ext uri="{FF2B5EF4-FFF2-40B4-BE49-F238E27FC236}">
                <a16:creationId xmlns:a16="http://schemas.microsoft.com/office/drawing/2014/main" id="{65D6A69E-938F-44CF-8DB0-501A4AA07093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91276" y="198708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Picture 72" descr="Background pattern&#10;&#10;Description automatically generated">
            <a:extLst>
              <a:ext uri="{FF2B5EF4-FFF2-40B4-BE49-F238E27FC236}">
                <a16:creationId xmlns:a16="http://schemas.microsoft.com/office/drawing/2014/main" id="{B7A43DD1-6D24-4BE0-956C-7F49010C5B36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253372" y="199491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Picture 74" descr="A picture containing light, dark&#10;&#10;Description automatically generated">
            <a:extLst>
              <a:ext uri="{FF2B5EF4-FFF2-40B4-BE49-F238E27FC236}">
                <a16:creationId xmlns:a16="http://schemas.microsoft.com/office/drawing/2014/main" id="{713DE424-27A0-42D4-B04D-850E68B9806A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217461" y="199491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Picture 76" descr="A picture containing grass, outdoor, green&#10;&#10;Description automatically generated">
            <a:extLst>
              <a:ext uri="{FF2B5EF4-FFF2-40B4-BE49-F238E27FC236}">
                <a16:creationId xmlns:a16="http://schemas.microsoft.com/office/drawing/2014/main" id="{1A50AF5E-9150-4391-8188-385D59071E1B}"/>
              </a:ext>
            </a:extLst>
          </p:cNvPr>
          <p:cNvPicPr>
            <a:picLocks noChangeAspect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87472" y="3548403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Picture 78" descr="Background pattern&#10;&#10;Description automatically generated">
            <a:extLst>
              <a:ext uri="{FF2B5EF4-FFF2-40B4-BE49-F238E27FC236}">
                <a16:creationId xmlns:a16="http://schemas.microsoft.com/office/drawing/2014/main" id="{337F8D5E-DE41-4710-A58F-66BECA5E3467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250263" y="3556296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Picture 80" descr="A picture containing dark, outdoor object, night, night sky&#10;&#10;Description automatically generated">
            <a:extLst>
              <a:ext uri="{FF2B5EF4-FFF2-40B4-BE49-F238E27FC236}">
                <a16:creationId xmlns:a16="http://schemas.microsoft.com/office/drawing/2014/main" id="{19137C66-E00B-409A-A38E-E4D5BC8E4D67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224556" y="3548403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Picture 82" descr="A picture containing outdoor, night sky&#10;&#10;Description automatically generated">
            <a:extLst>
              <a:ext uri="{FF2B5EF4-FFF2-40B4-BE49-F238E27FC236}">
                <a16:creationId xmlns:a16="http://schemas.microsoft.com/office/drawing/2014/main" id="{E3321C62-9EEB-437E-9BAA-0DCCBF73ACF9}"/>
              </a:ext>
            </a:extLst>
          </p:cNvPr>
          <p:cNvPicPr>
            <a:picLocks noChangeAspect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154854" y="3548403"/>
            <a:ext cx="933549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5" name="Picture 84" descr="A picture containing indoor, dark, star, night sky&#10;&#10;Description automatically generated">
            <a:extLst>
              <a:ext uri="{FF2B5EF4-FFF2-40B4-BE49-F238E27FC236}">
                <a16:creationId xmlns:a16="http://schemas.microsoft.com/office/drawing/2014/main" id="{27417959-8D02-4740-8469-C7FAA8814A56}"/>
              </a:ext>
            </a:extLst>
          </p:cNvPr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1157474" y="198708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1C4C5F4A-67C7-4884-9EAF-1E78B68ED457}"/>
              </a:ext>
            </a:extLst>
          </p:cNvPr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0189821" y="198708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Picture 88" descr="A picture containing indoor, star, outdoor object, night&#10;&#10;Description automatically generated">
            <a:extLst>
              <a:ext uri="{FF2B5EF4-FFF2-40B4-BE49-F238E27FC236}">
                <a16:creationId xmlns:a16="http://schemas.microsoft.com/office/drawing/2014/main" id="{9F27796D-C999-445C-9030-B7C04648875C}"/>
              </a:ext>
            </a:extLst>
          </p:cNvPr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249695" y="199197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Picture 90" descr="A picture containing dark, lit, light, night&#10;&#10;Description automatically generated">
            <a:extLst>
              <a:ext uri="{FF2B5EF4-FFF2-40B4-BE49-F238E27FC236}">
                <a16:creationId xmlns:a16="http://schemas.microsoft.com/office/drawing/2014/main" id="{4F504596-3AD8-4E4B-981D-2D5660406E1E}"/>
              </a:ext>
            </a:extLst>
          </p:cNvPr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9217946" y="1987082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F44911B1-89C3-460D-8FD0-8C7C5FAB1631}"/>
              </a:ext>
            </a:extLst>
          </p:cNvPr>
          <p:cNvPicPr>
            <a:picLocks noChangeAspect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225295" y="3554738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Picture 94" descr="Background pattern&#10;&#10;Description automatically generated">
            <a:extLst>
              <a:ext uri="{FF2B5EF4-FFF2-40B4-BE49-F238E27FC236}">
                <a16:creationId xmlns:a16="http://schemas.microsoft.com/office/drawing/2014/main" id="{DB1A2A36-A797-4F2E-A8CF-571D69618E22}"/>
              </a:ext>
            </a:extLst>
          </p:cNvPr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97075" y="3556296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7" name="Picture 96">
            <a:extLst>
              <a:ext uri="{FF2B5EF4-FFF2-40B4-BE49-F238E27FC236}">
                <a16:creationId xmlns:a16="http://schemas.microsoft.com/office/drawing/2014/main" id="{2FB384EB-C22B-4D97-8DFC-305D283FAE1A}"/>
              </a:ext>
            </a:extLst>
          </p:cNvPr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259664" y="3548403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47041E76-AE39-422D-9AC4-464F158FD081}"/>
              </a:ext>
            </a:extLst>
          </p:cNvPr>
          <p:cNvPicPr>
            <a:picLocks noChangeAspect="1"/>
          </p:cNvPicPr>
          <p:nvPr/>
        </p:nvPicPr>
        <p:blipFill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184234" y="3556296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2E24BE3C-09BD-40F1-9F6F-FDE122DCEC76}"/>
              </a:ext>
            </a:extLst>
          </p:cNvPr>
          <p:cNvSpPr txBox="1"/>
          <p:nvPr/>
        </p:nvSpPr>
        <p:spPr>
          <a:xfrm>
            <a:off x="297075" y="1736155"/>
            <a:ext cx="942906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DAPI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44D6615-57D8-4B01-9DDE-73879200B820}"/>
              </a:ext>
            </a:extLst>
          </p:cNvPr>
          <p:cNvSpPr txBox="1"/>
          <p:nvPr/>
        </p:nvSpPr>
        <p:spPr>
          <a:xfrm>
            <a:off x="8255669" y="1751051"/>
            <a:ext cx="938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DAPI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0F52883-7DD5-44C5-AF55-5B18062F8028}"/>
              </a:ext>
            </a:extLst>
          </p:cNvPr>
          <p:cNvSpPr txBox="1"/>
          <p:nvPr/>
        </p:nvSpPr>
        <p:spPr>
          <a:xfrm>
            <a:off x="4261384" y="1753380"/>
            <a:ext cx="938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DAPI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95E747B-0BAC-482C-879F-F795C161AEA8}"/>
              </a:ext>
            </a:extLst>
          </p:cNvPr>
          <p:cNvSpPr txBox="1"/>
          <p:nvPr/>
        </p:nvSpPr>
        <p:spPr>
          <a:xfrm>
            <a:off x="1263798" y="1751051"/>
            <a:ext cx="936251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Lamini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EF8EED7-02FE-4260-84FD-BBDAB4DA9007}"/>
              </a:ext>
            </a:extLst>
          </p:cNvPr>
          <p:cNvSpPr txBox="1"/>
          <p:nvPr/>
        </p:nvSpPr>
        <p:spPr>
          <a:xfrm>
            <a:off x="9220214" y="1741168"/>
            <a:ext cx="938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Lamin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E1DAA4C-47D1-439C-81F9-042E8838241B}"/>
              </a:ext>
            </a:extLst>
          </p:cNvPr>
          <p:cNvSpPr txBox="1"/>
          <p:nvPr/>
        </p:nvSpPr>
        <p:spPr>
          <a:xfrm>
            <a:off x="5232768" y="1740415"/>
            <a:ext cx="938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Laminin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B1C3338-ADB3-4362-8AEA-EE5AA7DA2A9E}"/>
              </a:ext>
            </a:extLst>
          </p:cNvPr>
          <p:cNvSpPr txBox="1"/>
          <p:nvPr/>
        </p:nvSpPr>
        <p:spPr>
          <a:xfrm>
            <a:off x="2228430" y="1740490"/>
            <a:ext cx="933359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/>
              <a:t>α</a:t>
            </a:r>
            <a:r>
              <a:rPr lang="en-US" sz="1400" b="1" dirty="0"/>
              <a:t>-SM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FA50E91-DEE0-481F-8E4F-76608184F0C5}"/>
              </a:ext>
            </a:extLst>
          </p:cNvPr>
          <p:cNvSpPr txBox="1"/>
          <p:nvPr/>
        </p:nvSpPr>
        <p:spPr>
          <a:xfrm>
            <a:off x="6192670" y="1741487"/>
            <a:ext cx="938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/>
              <a:t>α</a:t>
            </a:r>
            <a:r>
              <a:rPr lang="en-US" sz="1400" b="1" dirty="0"/>
              <a:t>-SM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D6B3EC1-DB7E-4AEB-B480-4A13D693662B}"/>
              </a:ext>
            </a:extLst>
          </p:cNvPr>
          <p:cNvSpPr txBox="1"/>
          <p:nvPr/>
        </p:nvSpPr>
        <p:spPr>
          <a:xfrm>
            <a:off x="10157617" y="1736155"/>
            <a:ext cx="938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/>
              <a:t>α</a:t>
            </a:r>
            <a:r>
              <a:rPr lang="en-US" sz="1400" b="1" dirty="0"/>
              <a:t>-SM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CC88446-7B6B-48CA-B0E9-F27E5F4D8C44}"/>
              </a:ext>
            </a:extLst>
          </p:cNvPr>
          <p:cNvSpPr txBox="1"/>
          <p:nvPr/>
        </p:nvSpPr>
        <p:spPr>
          <a:xfrm>
            <a:off x="3177623" y="1730867"/>
            <a:ext cx="943441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Merge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CAFB21E-F845-41CC-9A8A-02C7EF205B29}"/>
              </a:ext>
            </a:extLst>
          </p:cNvPr>
          <p:cNvSpPr txBox="1"/>
          <p:nvPr/>
        </p:nvSpPr>
        <p:spPr>
          <a:xfrm>
            <a:off x="11153592" y="1740415"/>
            <a:ext cx="938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Merged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4A87664-5011-42EF-9F6D-931111510748}"/>
              </a:ext>
            </a:extLst>
          </p:cNvPr>
          <p:cNvSpPr txBox="1"/>
          <p:nvPr/>
        </p:nvSpPr>
        <p:spPr>
          <a:xfrm>
            <a:off x="7158831" y="1730866"/>
            <a:ext cx="938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Merge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415D818-7E2C-45A1-AE1C-261555956960}"/>
              </a:ext>
            </a:extLst>
          </p:cNvPr>
          <p:cNvPicPr>
            <a:picLocks noChangeAspect="1"/>
          </p:cNvPicPr>
          <p:nvPr/>
        </p:nvPicPr>
        <p:blipFill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57474" y="3545328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BBC5B8D-7EE1-48AC-A526-C959830E2E97}"/>
              </a:ext>
            </a:extLst>
          </p:cNvPr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7139" y="3548403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 descr="A picture containing computer, outdoor object, close&#10;&#10;Description automatically generated">
            <a:extLst>
              <a:ext uri="{FF2B5EF4-FFF2-40B4-BE49-F238E27FC236}">
                <a16:creationId xmlns:a16="http://schemas.microsoft.com/office/drawing/2014/main" id="{8C356615-A186-4CFA-A27B-94B88FC81DDB}"/>
              </a:ext>
            </a:extLst>
          </p:cNvPr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2799" y="3551478"/>
            <a:ext cx="938738" cy="9387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A picture containing outdoor, night sky&#10;&#10;Description automatically generated">
            <a:extLst>
              <a:ext uri="{FF2B5EF4-FFF2-40B4-BE49-F238E27FC236}">
                <a16:creationId xmlns:a16="http://schemas.microsoft.com/office/drawing/2014/main" id="{693D7882-79B2-474B-A354-E7AA8F0B9330}"/>
              </a:ext>
            </a:extLst>
          </p:cNvPr>
          <p:cNvPicPr>
            <a:picLocks noChangeAspect="1"/>
          </p:cNvPicPr>
          <p:nvPr/>
        </p:nvPicPr>
        <p:blipFill>
          <a:blip r:embed="rId43" cstate="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88209" y="3548403"/>
            <a:ext cx="944888" cy="9448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D0DFAF6E-E9DA-476B-BE12-F5C5862568DB}"/>
              </a:ext>
            </a:extLst>
          </p:cNvPr>
          <p:cNvSpPr txBox="1"/>
          <p:nvPr/>
        </p:nvSpPr>
        <p:spPr>
          <a:xfrm>
            <a:off x="11621490" y="2787341"/>
            <a:ext cx="5053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µm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1ECAB9E9-F0E1-4176-BBCF-47C290765346}"/>
              </a:ext>
            </a:extLst>
          </p:cNvPr>
          <p:cNvCxnSpPr>
            <a:cxnSpLocks/>
          </p:cNvCxnSpPr>
          <p:nvPr/>
        </p:nvCxnSpPr>
        <p:spPr>
          <a:xfrm>
            <a:off x="11671042" y="2822721"/>
            <a:ext cx="39978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66A18BD9-31B9-41F6-91AE-36AF602D33B3}"/>
              </a:ext>
            </a:extLst>
          </p:cNvPr>
          <p:cNvSpPr txBox="1"/>
          <p:nvPr/>
        </p:nvSpPr>
        <p:spPr>
          <a:xfrm>
            <a:off x="228600" y="5966936"/>
            <a:ext cx="1187376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2. Myofibroblast quantification of periarticular knee tissue. </a:t>
            </a:r>
            <a:r>
              <a:rPr lang="en-US" sz="1400" dirty="0"/>
              <a:t>Myofibroblast quantification and representative immunofluorescence images of DAPI (blue), Laminin (red), </a:t>
            </a:r>
            <a:r>
              <a:rPr lang="el-GR" sz="1400" dirty="0"/>
              <a:t>α</a:t>
            </a:r>
            <a:r>
              <a:rPr lang="en-US" sz="1400" dirty="0"/>
              <a:t>-SMA (green), and a merged image of all three stains from the three patient groups (PTKA=primary TKA, RTKA-A=arthrofibrosis, RTKA-NA=non-arthrofibrosis). The scale bar applies to all images in this figure. </a:t>
            </a:r>
          </a:p>
        </p:txBody>
      </p:sp>
    </p:spTree>
    <p:extLst>
      <p:ext uri="{BB962C8B-B14F-4D97-AF65-F5344CB8AC3E}">
        <p14:creationId xmlns:p14="http://schemas.microsoft.com/office/powerpoint/2010/main" val="233706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45</TotalTime>
  <Words>174</Words>
  <Application>Microsoft Office PowerPoint</Application>
  <PresentationFormat>Widescreen</PresentationFormat>
  <Paragraphs>33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Histopathology Manuscript  Supplemental Figures</vt:lpstr>
      <vt:lpstr>Supplementary Figure 1</vt:lpstr>
      <vt:lpstr>Supplementary Figure 2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fton K Limberg</dc:creator>
  <cp:lastModifiedBy>Limberg, Afton K.</cp:lastModifiedBy>
  <cp:revision>202</cp:revision>
  <dcterms:created xsi:type="dcterms:W3CDTF">2019-07-02T19:02:55Z</dcterms:created>
  <dcterms:modified xsi:type="dcterms:W3CDTF">2022-03-25T12:27:48Z</dcterms:modified>
</cp:coreProperties>
</file>